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8" d="100"/>
          <a:sy n="78" d="100"/>
        </p:scale>
        <p:origin x="192" y="-3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ABEA-79F0-45ED-9A08-0FA09ABEFDB6}" type="datetimeFigureOut">
              <a:rPr lang="de-DE" smtClean="0"/>
              <a:t>18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17E47-8294-4090-AAF0-6BFBF08BC3D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1280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ABEA-79F0-45ED-9A08-0FA09ABEFDB6}" type="datetimeFigureOut">
              <a:rPr lang="de-DE" smtClean="0"/>
              <a:t>18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17E47-8294-4090-AAF0-6BFBF08BC3D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8933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ABEA-79F0-45ED-9A08-0FA09ABEFDB6}" type="datetimeFigureOut">
              <a:rPr lang="de-DE" smtClean="0"/>
              <a:t>18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17E47-8294-4090-AAF0-6BFBF08BC3D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456868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1_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838151" y="365223"/>
            <a:ext cx="10515294" cy="1325092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>
            <a:lvl1pPr indent="0">
              <a:buNone/>
              <a:defRPr/>
            </a:lvl1pPr>
          </a:lstStyle>
          <a:p>
            <a:pPr indent="0">
              <a:buNone/>
            </a:pPr>
            <a:endParaRPr lang="en-US" sz="1715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609408" y="1604582"/>
            <a:ext cx="10972093" cy="3976991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>
            <a:lvl1pPr indent="0">
              <a:lnSpc>
                <a:spcPct val="90000"/>
              </a:lnSpc>
              <a:spcBef>
                <a:spcPts val="1350"/>
              </a:spcBef>
              <a:buNone/>
              <a:defRPr/>
            </a:lvl1pPr>
          </a:lstStyle>
          <a:p>
            <a:pPr indent="0">
              <a:lnSpc>
                <a:spcPct val="90000"/>
              </a:lnSpc>
              <a:spcBef>
                <a:spcPts val="1417"/>
              </a:spcBef>
              <a:buNone/>
            </a:pPr>
            <a:endParaRPr lang="en-US" sz="2801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fld id="{F652A25E-8A3A-4CA4-9916-9D3F0F8C6881}" type="slidenum">
              <a:t>‹Nr.›</a:t>
            </a:fld>
            <a:endParaRPr/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1134062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ABEA-79F0-45ED-9A08-0FA09ABEFDB6}" type="datetimeFigureOut">
              <a:rPr lang="de-DE" smtClean="0"/>
              <a:t>18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17E47-8294-4090-AAF0-6BFBF08BC3D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4266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ABEA-79F0-45ED-9A08-0FA09ABEFDB6}" type="datetimeFigureOut">
              <a:rPr lang="de-DE" smtClean="0"/>
              <a:t>18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17E47-8294-4090-AAF0-6BFBF08BC3D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3451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ABEA-79F0-45ED-9A08-0FA09ABEFDB6}" type="datetimeFigureOut">
              <a:rPr lang="de-DE" smtClean="0"/>
              <a:t>18.03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17E47-8294-4090-AAF0-6BFBF08BC3D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95636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ABEA-79F0-45ED-9A08-0FA09ABEFDB6}" type="datetimeFigureOut">
              <a:rPr lang="de-DE" smtClean="0"/>
              <a:t>18.03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17E47-8294-4090-AAF0-6BFBF08BC3D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4296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ABEA-79F0-45ED-9A08-0FA09ABEFDB6}" type="datetimeFigureOut">
              <a:rPr lang="de-DE" smtClean="0"/>
              <a:t>18.03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17E47-8294-4090-AAF0-6BFBF08BC3D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5472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ABEA-79F0-45ED-9A08-0FA09ABEFDB6}" type="datetimeFigureOut">
              <a:rPr lang="de-DE" smtClean="0"/>
              <a:t>18.03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17E47-8294-4090-AAF0-6BFBF08BC3D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49300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ABEA-79F0-45ED-9A08-0FA09ABEFDB6}" type="datetimeFigureOut">
              <a:rPr lang="de-DE" smtClean="0"/>
              <a:t>18.03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17E47-8294-4090-AAF0-6BFBF08BC3D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3676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ABEA-79F0-45ED-9A08-0FA09ABEFDB6}" type="datetimeFigureOut">
              <a:rPr lang="de-DE" smtClean="0"/>
              <a:t>18.03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17E47-8294-4090-AAF0-6BFBF08BC3D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3150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F9ABEA-79F0-45ED-9A08-0FA09ABEFDB6}" type="datetimeFigureOut">
              <a:rPr lang="de-DE" smtClean="0"/>
              <a:t>18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717E47-8294-4090-AAF0-6BFBF08BC3D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0771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0E4F5779-7793-98A4-1806-E3B9962F796D}"/>
              </a:ext>
            </a:extLst>
          </p:cNvPr>
          <p:cNvSpPr txBox="1"/>
          <p:nvPr/>
        </p:nvSpPr>
        <p:spPr>
          <a:xfrm>
            <a:off x="1119883" y="4781709"/>
            <a:ext cx="10572108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Supplementary Figure S1: Characterization of sEVs derived from plasma of HNSCC patients and HDs. A: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Representative transmission electron microscopy images of sEVs from HNSCC patients (left) and HD (right), scale = 200 nm. </a:t>
            </a:r>
            <a:r>
              <a:rPr lang="en-US" sz="18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B: 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Western blot analysis of positive markers for EV isolation (CD63, CD9, TSG101) and negative markers (Grp94, ApoA1) present or absent in </a:t>
            </a:r>
            <a:r>
              <a:rPr lang="en-US" sz="18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sEV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 samples. M = marker, C = lysed cells, P = plasma. </a:t>
            </a:r>
            <a:r>
              <a:rPr lang="en-US" sz="18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C: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Representative size distribution of EVs measured by Nanoparticle Tracking Analysis (NTA) with a median size of 84 nm for HNSCC sEVs (left) and 82 nm for HD sEVs (right). </a:t>
            </a:r>
            <a:endParaRPr lang="de-DE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2" name="Grafik 1" descr="Ein Bild, das Screenshot, Schwarzweiß, monochrom, Kunst enthält.&#10;&#10;Automatisch generierte Beschreibung">
            <a:extLst>
              <a:ext uri="{FF2B5EF4-FFF2-40B4-BE49-F238E27FC236}">
                <a16:creationId xmlns:a16="http://schemas.microsoft.com/office/drawing/2014/main" id="{B4EBB0F9-D3D3-D806-6771-8866F822CD2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2159" y="256653"/>
            <a:ext cx="8323313" cy="4459744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4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>Universitätsklinikum Ul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uber Diana</dc:creator>
  <cp:lastModifiedBy>Diana Huber</cp:lastModifiedBy>
  <cp:revision>11</cp:revision>
  <dcterms:created xsi:type="dcterms:W3CDTF">2024-02-09T13:18:24Z</dcterms:created>
  <dcterms:modified xsi:type="dcterms:W3CDTF">2025-03-18T22:27:19Z</dcterms:modified>
</cp:coreProperties>
</file>